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58" r:id="rId2"/>
    <p:sldId id="259" r:id="rId3"/>
    <p:sldId id="260" r:id="rId4"/>
    <p:sldId id="261" r:id="rId5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294" autoAdjust="0"/>
    <p:restoredTop sz="94660"/>
  </p:normalViewPr>
  <p:slideViewPr>
    <p:cSldViewPr snapToGrid="0" showGuides="1">
      <p:cViewPr>
        <p:scale>
          <a:sx n="70" d="100"/>
          <a:sy n="70" d="100"/>
        </p:scale>
        <p:origin x="-1242" y="-11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064" cy="498104"/>
          </a:xfrm>
          <a:prstGeom prst="rect">
            <a:avLst/>
          </a:prstGeom>
        </p:spPr>
        <p:txBody>
          <a:bodyPr vert="horz" lIns="93113" tIns="46557" rIns="93113" bIns="46557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988" y="0"/>
            <a:ext cx="2945064" cy="498104"/>
          </a:xfrm>
          <a:prstGeom prst="rect">
            <a:avLst/>
          </a:prstGeom>
        </p:spPr>
        <p:txBody>
          <a:bodyPr vert="horz" lIns="93113" tIns="46557" rIns="93113" bIns="46557" rtlCol="0"/>
          <a:lstStyle>
            <a:lvl1pPr algn="r">
              <a:defRPr sz="1200"/>
            </a:lvl1pPr>
          </a:lstStyle>
          <a:p>
            <a:fld id="{C2F73123-8032-4591-BF38-9AD17B5A5840}" type="datetimeFigureOut">
              <a:rPr lang="en-GB" smtClean="0"/>
              <a:t>21/08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0688" y="1241425"/>
            <a:ext cx="5956300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13" tIns="46557" rIns="93113" bIns="46557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256" y="4777928"/>
            <a:ext cx="5437165" cy="3909068"/>
          </a:xfrm>
          <a:prstGeom prst="rect">
            <a:avLst/>
          </a:prstGeom>
        </p:spPr>
        <p:txBody>
          <a:bodyPr vert="horz" lIns="93113" tIns="46557" rIns="93113" bIns="46557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121"/>
            <a:ext cx="2945064" cy="498104"/>
          </a:xfrm>
          <a:prstGeom prst="rect">
            <a:avLst/>
          </a:prstGeom>
        </p:spPr>
        <p:txBody>
          <a:bodyPr vert="horz" lIns="93113" tIns="46557" rIns="93113" bIns="46557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988" y="9430121"/>
            <a:ext cx="2945064" cy="498104"/>
          </a:xfrm>
          <a:prstGeom prst="rect">
            <a:avLst/>
          </a:prstGeom>
        </p:spPr>
        <p:txBody>
          <a:bodyPr vert="horz" lIns="93113" tIns="46557" rIns="93113" bIns="46557" rtlCol="0" anchor="b"/>
          <a:lstStyle>
            <a:lvl1pPr algn="r">
              <a:defRPr sz="1200"/>
            </a:lvl1pPr>
          </a:lstStyle>
          <a:p>
            <a:fld id="{450148F1-C800-42F7-AEEC-06378D8671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25410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20688" y="1241425"/>
            <a:ext cx="5956300" cy="33512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50148F1-C800-42F7-AEEC-06378D8671B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176991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20688" y="1241425"/>
            <a:ext cx="5956300" cy="33512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50148F1-C800-42F7-AEEC-06378D8671B2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648792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20688" y="1241425"/>
            <a:ext cx="5956300" cy="33512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50148F1-C800-42F7-AEEC-06378D8671B2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865640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420688" y="1241425"/>
            <a:ext cx="5956300" cy="335121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50148F1-C800-42F7-AEEC-06378D8671B2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20657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7D8B-6ECD-4005-AA68-7A01D5D21D75}" type="datetimeFigureOut">
              <a:rPr lang="en-GB" smtClean="0"/>
              <a:t>21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0D129-3C11-4C81-AEA6-124648D53B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64579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7D8B-6ECD-4005-AA68-7A01D5D21D75}" type="datetimeFigureOut">
              <a:rPr lang="en-GB" smtClean="0"/>
              <a:t>21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0D129-3C11-4C81-AEA6-124648D53B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1691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7D8B-6ECD-4005-AA68-7A01D5D21D75}" type="datetimeFigureOut">
              <a:rPr lang="en-GB" smtClean="0"/>
              <a:t>21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0D129-3C11-4C81-AEA6-124648D53B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41861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7D8B-6ECD-4005-AA68-7A01D5D21D75}" type="datetimeFigureOut">
              <a:rPr lang="en-GB" smtClean="0"/>
              <a:t>21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0D129-3C11-4C81-AEA6-124648D53B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9479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9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5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7D8B-6ECD-4005-AA68-7A01D5D21D75}" type="datetimeFigureOut">
              <a:rPr lang="en-GB" smtClean="0"/>
              <a:t>21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0D129-3C11-4C81-AEA6-124648D53B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3396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7D8B-6ECD-4005-AA68-7A01D5D21D75}" type="datetimeFigureOut">
              <a:rPr lang="en-GB" smtClean="0"/>
              <a:t>21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0D129-3C11-4C81-AEA6-124648D53B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95300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7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7D8B-6ECD-4005-AA68-7A01D5D21D75}" type="datetimeFigureOut">
              <a:rPr lang="en-GB" smtClean="0"/>
              <a:t>21/08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0D129-3C11-4C81-AEA6-124648D53B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73062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7D8B-6ECD-4005-AA68-7A01D5D21D75}" type="datetimeFigureOut">
              <a:rPr lang="en-GB" smtClean="0"/>
              <a:t>21/08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0D129-3C11-4C81-AEA6-124648D53B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2699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7D8B-6ECD-4005-AA68-7A01D5D21D75}" type="datetimeFigureOut">
              <a:rPr lang="en-GB" smtClean="0"/>
              <a:t>21/08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0D129-3C11-4C81-AEA6-124648D53B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38493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1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7D8B-6ECD-4005-AA68-7A01D5D21D75}" type="datetimeFigureOut">
              <a:rPr lang="en-GB" smtClean="0"/>
              <a:t>21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0D129-3C11-4C81-AEA6-124648D53B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46244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457200"/>
            <a:ext cx="393223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1" cy="487362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057400"/>
            <a:ext cx="393223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47D8B-6ECD-4005-AA68-7A01D5D21D75}" type="datetimeFigureOut">
              <a:rPr lang="en-GB" smtClean="0"/>
              <a:t>21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40D129-3C11-4C81-AEA6-124648D53B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6599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47D8B-6ECD-4005-AA68-7A01D5D21D75}" type="datetimeFigureOut">
              <a:rPr lang="en-GB" smtClean="0"/>
              <a:t>21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40D129-3C11-4C81-AEA6-124648D53B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38252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Box 70"/>
          <p:cNvSpPr txBox="1"/>
          <p:nvPr/>
        </p:nvSpPr>
        <p:spPr>
          <a:xfrm>
            <a:off x="4805740" y="912364"/>
            <a:ext cx="24110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A: PAUP 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032" y="1453814"/>
            <a:ext cx="11122917" cy="54041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10430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200" y="1362782"/>
            <a:ext cx="11313988" cy="549521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805740" y="912364"/>
            <a:ext cx="21616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B: NJ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9507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313" y="1453814"/>
            <a:ext cx="11300342" cy="540418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4805740" y="912364"/>
            <a:ext cx="22605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C: ML 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29433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496" y="1239120"/>
            <a:ext cx="11300340" cy="561888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805740" y="912364"/>
            <a:ext cx="261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D: Mr Bayes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31589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4</TotalTime>
  <Words>25</Words>
  <Application>Microsoft Office PowerPoint</Application>
  <PresentationFormat>Custom</PresentationFormat>
  <Paragraphs>8</Paragraphs>
  <Slides>4</Slides>
  <Notes>4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tter</dc:title>
  <dc:creator>Protter</dc:creator>
  <cp:lastModifiedBy>SMITH Jacqueline</cp:lastModifiedBy>
  <cp:revision>31</cp:revision>
  <cp:lastPrinted>2014-08-15T12:35:45Z</cp:lastPrinted>
  <dcterms:created xsi:type="dcterms:W3CDTF">2013-12-20T12:28:46Z</dcterms:created>
  <dcterms:modified xsi:type="dcterms:W3CDTF">2014-08-21T09:04:23Z</dcterms:modified>
</cp:coreProperties>
</file>